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6" r:id="rId2"/>
  </p:sldIdLst>
  <p:sldSz cx="12192000" cy="6858000"/>
  <p:notesSz cx="6858000" cy="9144000"/>
  <p:defaultTextStyle>
    <a:defPPr>
      <a:defRPr lang="en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93" autoAdjust="0"/>
    <p:restoredTop sz="94660"/>
  </p:normalViewPr>
  <p:slideViewPr>
    <p:cSldViewPr snapToGrid="0" showGuides="1">
      <p:cViewPr varScale="1">
        <p:scale>
          <a:sx n="103" d="100"/>
          <a:sy n="103" d="100"/>
        </p:scale>
        <p:origin x="798" y="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AC75DA-876C-9814-7DE4-179093D6848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C5BA292-FE38-AEFF-D734-A5DE75EE379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3341F4E-8D10-0C49-A11F-F8BB6ACDF4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60E3A5-A250-A72D-0655-8681028415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3E4995-1A25-5613-3CB7-F8F1FBCA1B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1165811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153C7E-249C-C608-C640-68C35A1FFF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16A180C-B2AB-BFA0-1DD2-C57FFCE6D56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0D53947-AF88-AD42-11FB-5027FC7703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91670A-E8BF-FBE7-B76E-6AAB0061A1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CD2F002-18E4-F467-0691-217B8C1193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0329213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09086AB-956A-6EF1-5DBB-DC43E5DBA19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44E7BCA-4ADA-1998-0E0E-F5021CC4F32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4248976-69F8-ED46-0B5C-F590C0710C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A7D4A30-63B2-A4DD-4502-3B1DDB582C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C78DD4B-AD6E-9022-46A0-57067D699D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9898131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156398-2E91-DCCA-7A89-1D84D13785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8DCC001-5649-AB4E-6494-ACD12990FE9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878D962-9ED6-6567-7417-E76244A7FC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6E149EF-7CD2-8C65-7EEB-76B4D83A3D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18CDEF-2DDF-E3D9-3B5E-61A639C609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5242059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F82F80-993F-D2FB-0DBA-485FD4D8FF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F56A2D8-14C2-C746-3B1D-933005CAF8F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1437D5-A396-81BA-47E0-EEEFE0AFB3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6855B5-4FF2-A87D-2D42-1C91F9C53A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93100FB-51DD-A3CD-2E67-524D388911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0730980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228DD7-A945-C1E3-815F-26FD23C195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A54B4C6-90E7-8E99-6217-194852FC0D0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D02E0C6-144D-ECB8-72A3-2748FD7AE3D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943D97D-D2D0-176E-562F-6CFEEC3FE4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62ABEDC-26DF-E91A-B279-A0E42BB3AE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E0BB212-CE38-9BFC-1BEE-003AE576C8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9784425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006D5F-0CE7-3109-267A-DDE0F6EEDD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ACE52BF-CBF4-9A79-43C2-00FD8F60467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8ED3AA0-6116-EEB4-2ADD-46D16E7A9A7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DA17345-989F-CAFF-E538-29AECBE2AEC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4AAA2BB-06A9-515E-E6D7-40B6761B8A5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24B79C1-3F57-F46E-C41E-754344EB6C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AD21308-54ED-803A-630E-076B9A4256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E54443E-6521-6B03-E4A5-0DF282F47E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7990429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5FE944-4B0A-DBE3-1026-336F0EA6D6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1D9B25A-F645-7109-DFD8-8A3E209DC0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B3639BA-8140-AFE8-E84A-5AE1DB01F1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05D4F7E-18F3-E380-29A4-A761E131AB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3387314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DECAAC5-A8F4-D635-2AF1-B6AF071C8F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20E0357-85EC-A8C4-13EE-E9DF67E411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A465C70-5E4A-37F7-0442-2A0CBD8EE1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6566154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185375-7F61-062D-AB1C-DF9C5654B2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B03E477-406E-C5F5-4B78-E5E53C0548E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87B9FAC-3F01-D384-6DA5-DF78FA169FD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965789E-63D7-54B7-0C33-A70C241BF4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287737B-EC50-0FEF-DA55-B81A8B1A34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0094EC0-CEAE-21D8-8AE5-5B165533CF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3374772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DD1A9F-C6F0-792B-050C-29C4DFDFD9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FE15C31-1847-8321-3FB3-09E6B813D7B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D3766E6-64D7-4E38-1599-707BD73E385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16E8DF5-E161-B255-0C7B-9FABBF9CCA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FA97C65-43FA-49B8-125B-AC7F7FA259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517EA60-AE12-BB00-E775-17EE0201D8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42422843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81378DE-852B-CFB7-9A7A-0835366275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D1828B3-FE3D-3926-B625-63B9F59B690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0B7AED3-ED14-68E6-52DD-3E815FF5F7B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41B404-05E3-EF5C-F3ED-A45358ABC61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E35E14-3BAD-3053-0D55-C41CCC65FB1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0616706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62FFF1CB-998C-45F3-9CF9-2CDD85D7BEB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898" t="41234" r="6458" b="13668"/>
          <a:stretch/>
        </p:blipFill>
        <p:spPr bwMode="auto">
          <a:xfrm>
            <a:off x="1427084" y="3429000"/>
            <a:ext cx="4035288" cy="2776331"/>
          </a:xfrm>
          <a:prstGeom prst="rect">
            <a:avLst/>
          </a:prstGeom>
          <a:ln>
            <a:noFill/>
          </a:ln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9BA97318-919E-4C7C-8F02-A414256BBB7E}"/>
              </a:ext>
            </a:extLst>
          </p:cNvPr>
          <p:cNvSpPr/>
          <p:nvPr/>
        </p:nvSpPr>
        <p:spPr>
          <a:xfrm>
            <a:off x="1900784" y="4825422"/>
            <a:ext cx="2818712" cy="261457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DFED8AE-2B6F-487F-ABF2-CE8A4C24C6CC}"/>
              </a:ext>
            </a:extLst>
          </p:cNvPr>
          <p:cNvSpPr txBox="1"/>
          <p:nvPr/>
        </p:nvSpPr>
        <p:spPr>
          <a:xfrm>
            <a:off x="4885572" y="4825422"/>
            <a:ext cx="8242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DE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EB73E5A-E95A-120E-603F-C532C8E38DC4}"/>
              </a:ext>
            </a:extLst>
          </p:cNvPr>
          <p:cNvSpPr txBox="1"/>
          <p:nvPr/>
        </p:nvSpPr>
        <p:spPr>
          <a:xfrm>
            <a:off x="1014222" y="1025027"/>
            <a:ext cx="577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lot 1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64FBD31-F67A-E98A-3F7F-8D658CA32D92}"/>
              </a:ext>
            </a:extLst>
          </p:cNvPr>
          <p:cNvSpPr txBox="1"/>
          <p:nvPr/>
        </p:nvSpPr>
        <p:spPr>
          <a:xfrm rot="16200000">
            <a:off x="1964574" y="2960649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4292182-01BF-AC19-0927-3D0B6CA64A98}"/>
              </a:ext>
            </a:extLst>
          </p:cNvPr>
          <p:cNvSpPr txBox="1"/>
          <p:nvPr/>
        </p:nvSpPr>
        <p:spPr>
          <a:xfrm rot="16200000">
            <a:off x="2602231" y="1750911"/>
            <a:ext cx="2809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 + ZBP1-S-Sc (moderate)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F6B79F5-8023-C87A-04AE-21E2905F7583}"/>
              </a:ext>
            </a:extLst>
          </p:cNvPr>
          <p:cNvSpPr txBox="1"/>
          <p:nvPr/>
        </p:nvSpPr>
        <p:spPr>
          <a:xfrm rot="16200000">
            <a:off x="2142691" y="2672028"/>
            <a:ext cx="9877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2B96172-1618-8360-28FB-DF206C896626}"/>
              </a:ext>
            </a:extLst>
          </p:cNvPr>
          <p:cNvSpPr txBox="1"/>
          <p:nvPr/>
        </p:nvSpPr>
        <p:spPr>
          <a:xfrm rot="16200000">
            <a:off x="2901980" y="2551654"/>
            <a:ext cx="13003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mZ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L-NG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050F059-7FB8-31B3-6941-614FBB8F437B}"/>
              </a:ext>
            </a:extLst>
          </p:cNvPr>
          <p:cNvSpPr txBox="1"/>
          <p:nvPr/>
        </p:nvSpPr>
        <p:spPr>
          <a:xfrm rot="16200000">
            <a:off x="2620369" y="2724778"/>
            <a:ext cx="9541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S-Sc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57FC917-3FE3-F71E-96A1-8AB7BA0FC779}"/>
              </a:ext>
            </a:extLst>
          </p:cNvPr>
          <p:cNvSpPr txBox="1"/>
          <p:nvPr/>
        </p:nvSpPr>
        <p:spPr>
          <a:xfrm rot="16200000">
            <a:off x="3063077" y="1797168"/>
            <a:ext cx="2809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 + ZBP1-S-Sc (high)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EF703611-280E-CB2E-A05B-60AC2E7D9BED}"/>
              </a:ext>
            </a:extLst>
          </p:cNvPr>
          <p:cNvCxnSpPr>
            <a:cxnSpLocks/>
          </p:cNvCxnSpPr>
          <p:nvPr/>
        </p:nvCxnSpPr>
        <p:spPr>
          <a:xfrm>
            <a:off x="1985267" y="3304662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7111C32C-668C-B72C-A79B-285DEFB31170}"/>
              </a:ext>
            </a:extLst>
          </p:cNvPr>
          <p:cNvCxnSpPr>
            <a:cxnSpLocks/>
          </p:cNvCxnSpPr>
          <p:nvPr/>
        </p:nvCxnSpPr>
        <p:spPr>
          <a:xfrm>
            <a:off x="2449093" y="3304662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2825C386-C644-14BC-EB73-BB331A36E872}"/>
              </a:ext>
            </a:extLst>
          </p:cNvPr>
          <p:cNvCxnSpPr>
            <a:cxnSpLocks/>
          </p:cNvCxnSpPr>
          <p:nvPr/>
        </p:nvCxnSpPr>
        <p:spPr>
          <a:xfrm>
            <a:off x="2909938" y="3304413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A1D59EDE-D8C5-7981-D56D-0A2655CE0BE7}"/>
              </a:ext>
            </a:extLst>
          </p:cNvPr>
          <p:cNvCxnSpPr>
            <a:cxnSpLocks/>
          </p:cNvCxnSpPr>
          <p:nvPr/>
        </p:nvCxnSpPr>
        <p:spPr>
          <a:xfrm>
            <a:off x="3364418" y="3304413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2BF11334-921C-7F27-8ABC-20BAD3C15797}"/>
              </a:ext>
            </a:extLst>
          </p:cNvPr>
          <p:cNvCxnSpPr>
            <a:cxnSpLocks/>
          </p:cNvCxnSpPr>
          <p:nvPr/>
        </p:nvCxnSpPr>
        <p:spPr>
          <a:xfrm>
            <a:off x="3814067" y="3306828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74E4D6EA-4952-93A6-FACD-D1D5B8F20651}"/>
              </a:ext>
            </a:extLst>
          </p:cNvPr>
          <p:cNvCxnSpPr>
            <a:cxnSpLocks/>
          </p:cNvCxnSpPr>
          <p:nvPr/>
        </p:nvCxnSpPr>
        <p:spPr>
          <a:xfrm>
            <a:off x="4271267" y="3304413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4BEF99D0-CD4F-45AC-4004-E7A2ADFF4554}"/>
              </a:ext>
            </a:extLst>
          </p:cNvPr>
          <p:cNvSpPr txBox="1"/>
          <p:nvPr/>
        </p:nvSpPr>
        <p:spPr>
          <a:xfrm>
            <a:off x="1395027" y="3340331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BEC8756-5DF0-259F-3BE5-13783BD2BB71}"/>
              </a:ext>
            </a:extLst>
          </p:cNvPr>
          <p:cNvSpPr txBox="1"/>
          <p:nvPr/>
        </p:nvSpPr>
        <p:spPr>
          <a:xfrm>
            <a:off x="1014222" y="3619798"/>
            <a:ext cx="9092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mricasan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BFD97CA-7187-F426-05AB-AFF8A55FF89B}"/>
              </a:ext>
            </a:extLst>
          </p:cNvPr>
          <p:cNvSpPr txBox="1"/>
          <p:nvPr/>
        </p:nvSpPr>
        <p:spPr>
          <a:xfrm>
            <a:off x="1920662" y="3323605"/>
            <a:ext cx="28200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Symbol" panose="05050102010706020507" pitchFamily="18" charset="2"/>
                <a:cs typeface="Arial" panose="020B0604020202020204" pitchFamily="34" charset="0"/>
              </a:rPr>
              <a:t>+    +    +    +    +    +    +   +    +   +    +    +</a:t>
            </a:r>
            <a:endParaRPr lang="en-DE" sz="12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740D61CF-2A81-2573-00A9-83F1D8A5B80B}"/>
              </a:ext>
            </a:extLst>
          </p:cNvPr>
          <p:cNvSpPr txBox="1"/>
          <p:nvPr/>
        </p:nvSpPr>
        <p:spPr>
          <a:xfrm>
            <a:off x="1920662" y="3572991"/>
            <a:ext cx="28200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Symbol" panose="05050102010706020507" pitchFamily="18" charset="2"/>
                <a:cs typeface="Arial" panose="020B0604020202020204" pitchFamily="34" charset="0"/>
              </a:rPr>
              <a:t>-    +    -    +    -    +    -   +    -   +    -    +</a:t>
            </a:r>
            <a:endParaRPr lang="en-DE" sz="12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pic>
        <p:nvPicPr>
          <p:cNvPr id="22" name="Picture 21">
            <a:extLst>
              <a:ext uri="{FF2B5EF4-FFF2-40B4-BE49-F238E27FC236}">
                <a16:creationId xmlns:a16="http://schemas.microsoft.com/office/drawing/2014/main" id="{39998894-D2D4-FBF3-C041-6EF68102534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028" t="2982" r="6960" b="57343"/>
          <a:stretch/>
        </p:blipFill>
        <p:spPr bwMode="auto">
          <a:xfrm>
            <a:off x="6996267" y="3572991"/>
            <a:ext cx="4121830" cy="2478155"/>
          </a:xfrm>
          <a:prstGeom prst="rect">
            <a:avLst/>
          </a:prstGeom>
          <a:ln>
            <a:noFill/>
          </a:ln>
        </p:spPr>
      </p:pic>
      <p:sp>
        <p:nvSpPr>
          <p:cNvPr id="23" name="Rectangle 22">
            <a:extLst>
              <a:ext uri="{FF2B5EF4-FFF2-40B4-BE49-F238E27FC236}">
                <a16:creationId xmlns:a16="http://schemas.microsoft.com/office/drawing/2014/main" id="{3CF429E0-BB7B-EBD4-EC56-CEED01F06EC5}"/>
              </a:ext>
            </a:extLst>
          </p:cNvPr>
          <p:cNvSpPr/>
          <p:nvPr/>
        </p:nvSpPr>
        <p:spPr>
          <a:xfrm>
            <a:off x="7412457" y="4804098"/>
            <a:ext cx="3024000" cy="26331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64DF6D4D-D307-6720-E8DF-C6561B30A063}"/>
              </a:ext>
            </a:extLst>
          </p:cNvPr>
          <p:cNvSpPr txBox="1"/>
          <p:nvPr/>
        </p:nvSpPr>
        <p:spPr>
          <a:xfrm>
            <a:off x="10578156" y="4812068"/>
            <a:ext cx="8242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DE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5A5F011D-98CB-85D0-575E-E7AFBAFD5620}"/>
              </a:ext>
            </a:extLst>
          </p:cNvPr>
          <p:cNvSpPr txBox="1"/>
          <p:nvPr/>
        </p:nvSpPr>
        <p:spPr>
          <a:xfrm rot="16200000">
            <a:off x="7558367" y="3109966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CFB10714-02FC-2AED-C10C-A56FEBE8269D}"/>
              </a:ext>
            </a:extLst>
          </p:cNvPr>
          <p:cNvSpPr txBox="1"/>
          <p:nvPr/>
        </p:nvSpPr>
        <p:spPr>
          <a:xfrm rot="16200000">
            <a:off x="8196024" y="1900228"/>
            <a:ext cx="2809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 + ZBP1-S-Sc (moderate)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2804A33E-36F1-0212-15A6-5C4379C453FC}"/>
              </a:ext>
            </a:extLst>
          </p:cNvPr>
          <p:cNvSpPr txBox="1"/>
          <p:nvPr/>
        </p:nvSpPr>
        <p:spPr>
          <a:xfrm rot="16200000">
            <a:off x="7736484" y="2821345"/>
            <a:ext cx="9877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60EBA146-B194-54A3-836F-1205B33C78A9}"/>
              </a:ext>
            </a:extLst>
          </p:cNvPr>
          <p:cNvSpPr txBox="1"/>
          <p:nvPr/>
        </p:nvSpPr>
        <p:spPr>
          <a:xfrm rot="16200000">
            <a:off x="8495773" y="2700971"/>
            <a:ext cx="13003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mZ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L-NG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B3486E8D-4FC2-840D-C601-4BF1113B8C41}"/>
              </a:ext>
            </a:extLst>
          </p:cNvPr>
          <p:cNvSpPr txBox="1"/>
          <p:nvPr/>
        </p:nvSpPr>
        <p:spPr>
          <a:xfrm rot="16200000">
            <a:off x="8214162" y="2874095"/>
            <a:ext cx="9541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S-Sc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A999E6DF-B907-A696-12A4-FF5396F157EE}"/>
              </a:ext>
            </a:extLst>
          </p:cNvPr>
          <p:cNvSpPr txBox="1"/>
          <p:nvPr/>
        </p:nvSpPr>
        <p:spPr>
          <a:xfrm rot="16200000">
            <a:off x="8656870" y="1946485"/>
            <a:ext cx="2809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 + ZBP1-S-Sc (high)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882FF70A-4906-C0BE-D982-9713ADDFA682}"/>
              </a:ext>
            </a:extLst>
          </p:cNvPr>
          <p:cNvCxnSpPr>
            <a:cxnSpLocks/>
          </p:cNvCxnSpPr>
          <p:nvPr/>
        </p:nvCxnSpPr>
        <p:spPr>
          <a:xfrm>
            <a:off x="7579060" y="3453979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A427B271-B6C0-7365-661F-006D0F19A0AE}"/>
              </a:ext>
            </a:extLst>
          </p:cNvPr>
          <p:cNvCxnSpPr>
            <a:cxnSpLocks/>
          </p:cNvCxnSpPr>
          <p:nvPr/>
        </p:nvCxnSpPr>
        <p:spPr>
          <a:xfrm>
            <a:off x="8042886" y="3453979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64A91137-FEA2-D5CE-D8B6-0FB056E98EDF}"/>
              </a:ext>
            </a:extLst>
          </p:cNvPr>
          <p:cNvCxnSpPr>
            <a:cxnSpLocks/>
          </p:cNvCxnSpPr>
          <p:nvPr/>
        </p:nvCxnSpPr>
        <p:spPr>
          <a:xfrm>
            <a:off x="8503731" y="3453730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8E61E31F-4E11-852A-6364-D0934C743D11}"/>
              </a:ext>
            </a:extLst>
          </p:cNvPr>
          <p:cNvCxnSpPr>
            <a:cxnSpLocks/>
          </p:cNvCxnSpPr>
          <p:nvPr/>
        </p:nvCxnSpPr>
        <p:spPr>
          <a:xfrm>
            <a:off x="8958211" y="3453730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00E2F2C9-D28F-E6AF-C720-8B4C36E4B37A}"/>
              </a:ext>
            </a:extLst>
          </p:cNvPr>
          <p:cNvCxnSpPr>
            <a:cxnSpLocks/>
          </p:cNvCxnSpPr>
          <p:nvPr/>
        </p:nvCxnSpPr>
        <p:spPr>
          <a:xfrm>
            <a:off x="9407860" y="3456145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6A518CEA-64F2-3234-8395-A82CA4E48D70}"/>
              </a:ext>
            </a:extLst>
          </p:cNvPr>
          <p:cNvCxnSpPr>
            <a:cxnSpLocks/>
          </p:cNvCxnSpPr>
          <p:nvPr/>
        </p:nvCxnSpPr>
        <p:spPr>
          <a:xfrm>
            <a:off x="9865060" y="3453730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8D0595C7-C643-F408-9114-783CCFA90CF8}"/>
              </a:ext>
            </a:extLst>
          </p:cNvPr>
          <p:cNvSpPr txBox="1"/>
          <p:nvPr/>
        </p:nvSpPr>
        <p:spPr>
          <a:xfrm>
            <a:off x="6988820" y="3489648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A90971F7-C6D2-4DC4-8EFF-80396C7B7FC3}"/>
              </a:ext>
            </a:extLst>
          </p:cNvPr>
          <p:cNvSpPr txBox="1"/>
          <p:nvPr/>
        </p:nvSpPr>
        <p:spPr>
          <a:xfrm>
            <a:off x="6608015" y="3769115"/>
            <a:ext cx="9092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mricasan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C126B5F1-236D-D455-4721-050F62914500}"/>
              </a:ext>
            </a:extLst>
          </p:cNvPr>
          <p:cNvSpPr txBox="1"/>
          <p:nvPr/>
        </p:nvSpPr>
        <p:spPr>
          <a:xfrm>
            <a:off x="7514455" y="3472922"/>
            <a:ext cx="28200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Symbol" panose="05050102010706020507" pitchFamily="18" charset="2"/>
                <a:cs typeface="Arial" panose="020B0604020202020204" pitchFamily="34" charset="0"/>
              </a:rPr>
              <a:t>+    +    +    +    +    +    +   +    +   +    +    +</a:t>
            </a:r>
            <a:endParaRPr lang="en-DE" sz="12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AD16144A-B55B-A4AC-FECB-8166C3D9F4B5}"/>
              </a:ext>
            </a:extLst>
          </p:cNvPr>
          <p:cNvSpPr txBox="1"/>
          <p:nvPr/>
        </p:nvSpPr>
        <p:spPr>
          <a:xfrm>
            <a:off x="7514455" y="3722308"/>
            <a:ext cx="28200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Symbol" panose="05050102010706020507" pitchFamily="18" charset="2"/>
                <a:cs typeface="Arial" panose="020B0604020202020204" pitchFamily="34" charset="0"/>
              </a:rPr>
              <a:t>-    +    -    +    -    +    -   +    -   +    -    +</a:t>
            </a:r>
            <a:endParaRPr lang="en-DE" sz="12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9634FB0A-9551-A3D2-A88A-765C9B427A88}"/>
              </a:ext>
            </a:extLst>
          </p:cNvPr>
          <p:cNvSpPr txBox="1"/>
          <p:nvPr/>
        </p:nvSpPr>
        <p:spPr>
          <a:xfrm>
            <a:off x="6773925" y="1025026"/>
            <a:ext cx="577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lot 2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CBF34FA7-192D-401A-9787-46B59A9B98DD}"/>
              </a:ext>
            </a:extLst>
          </p:cNvPr>
          <p:cNvCxnSpPr>
            <a:cxnSpLocks/>
          </p:cNvCxnSpPr>
          <p:nvPr/>
        </p:nvCxnSpPr>
        <p:spPr>
          <a:xfrm>
            <a:off x="7086434" y="4924505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3" name="TextBox 36">
            <a:extLst>
              <a:ext uri="{FF2B5EF4-FFF2-40B4-BE49-F238E27FC236}">
                <a16:creationId xmlns:a16="http://schemas.microsoft.com/office/drawing/2014/main" id="{015C0B8D-58E3-4DE6-BF19-454CE4EFE6F3}"/>
              </a:ext>
            </a:extLst>
          </p:cNvPr>
          <p:cNvSpPr txBox="1"/>
          <p:nvPr/>
        </p:nvSpPr>
        <p:spPr>
          <a:xfrm>
            <a:off x="6758048" y="478243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648850D4-1A6F-4202-BA77-74E331369C68}"/>
              </a:ext>
            </a:extLst>
          </p:cNvPr>
          <p:cNvCxnSpPr>
            <a:cxnSpLocks/>
          </p:cNvCxnSpPr>
          <p:nvPr/>
        </p:nvCxnSpPr>
        <p:spPr>
          <a:xfrm>
            <a:off x="7086434" y="5147538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5" name="TextBox 38">
            <a:extLst>
              <a:ext uri="{FF2B5EF4-FFF2-40B4-BE49-F238E27FC236}">
                <a16:creationId xmlns:a16="http://schemas.microsoft.com/office/drawing/2014/main" id="{17857408-0151-4A47-A829-79D29D6676A7}"/>
              </a:ext>
            </a:extLst>
          </p:cNvPr>
          <p:cNvSpPr txBox="1"/>
          <p:nvPr/>
        </p:nvSpPr>
        <p:spPr>
          <a:xfrm>
            <a:off x="6758048" y="500546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F10E8EB3-7ABC-44AF-817B-43C42A7602A7}"/>
              </a:ext>
            </a:extLst>
          </p:cNvPr>
          <p:cNvCxnSpPr>
            <a:cxnSpLocks/>
          </p:cNvCxnSpPr>
          <p:nvPr/>
        </p:nvCxnSpPr>
        <p:spPr>
          <a:xfrm>
            <a:off x="7092570" y="4575912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" name="TextBox 40">
            <a:extLst>
              <a:ext uri="{FF2B5EF4-FFF2-40B4-BE49-F238E27FC236}">
                <a16:creationId xmlns:a16="http://schemas.microsoft.com/office/drawing/2014/main" id="{4FBBD120-0B82-462B-A1A0-ADED2852B0B5}"/>
              </a:ext>
            </a:extLst>
          </p:cNvPr>
          <p:cNvSpPr txBox="1"/>
          <p:nvPr/>
        </p:nvSpPr>
        <p:spPr>
          <a:xfrm>
            <a:off x="6764184" y="443384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58655F5B-6626-43D2-B335-371BEE968A8D}"/>
              </a:ext>
            </a:extLst>
          </p:cNvPr>
          <p:cNvCxnSpPr>
            <a:cxnSpLocks/>
          </p:cNvCxnSpPr>
          <p:nvPr/>
        </p:nvCxnSpPr>
        <p:spPr>
          <a:xfrm>
            <a:off x="7086434" y="4371111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9" name="TextBox 42">
            <a:extLst>
              <a:ext uri="{FF2B5EF4-FFF2-40B4-BE49-F238E27FC236}">
                <a16:creationId xmlns:a16="http://schemas.microsoft.com/office/drawing/2014/main" id="{914F6FFB-42E7-41F6-B136-B2A94CF3501B}"/>
              </a:ext>
            </a:extLst>
          </p:cNvPr>
          <p:cNvSpPr txBox="1"/>
          <p:nvPr/>
        </p:nvSpPr>
        <p:spPr>
          <a:xfrm>
            <a:off x="6758048" y="422226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4DC44C71-8904-48A6-BFEC-21720B43FB9B}"/>
              </a:ext>
            </a:extLst>
          </p:cNvPr>
          <p:cNvCxnSpPr>
            <a:cxnSpLocks/>
          </p:cNvCxnSpPr>
          <p:nvPr/>
        </p:nvCxnSpPr>
        <p:spPr>
          <a:xfrm>
            <a:off x="7086434" y="4256873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1" name="TextBox 42">
            <a:extLst>
              <a:ext uri="{FF2B5EF4-FFF2-40B4-BE49-F238E27FC236}">
                <a16:creationId xmlns:a16="http://schemas.microsoft.com/office/drawing/2014/main" id="{2CA58868-248F-4A84-8F93-6A902DF23820}"/>
              </a:ext>
            </a:extLst>
          </p:cNvPr>
          <p:cNvSpPr txBox="1"/>
          <p:nvPr/>
        </p:nvSpPr>
        <p:spPr>
          <a:xfrm>
            <a:off x="6673088" y="4089368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1C341870-AE38-4D44-8FE1-A47CEE3A7E3F}"/>
              </a:ext>
            </a:extLst>
          </p:cNvPr>
          <p:cNvCxnSpPr>
            <a:cxnSpLocks/>
          </p:cNvCxnSpPr>
          <p:nvPr/>
        </p:nvCxnSpPr>
        <p:spPr>
          <a:xfrm>
            <a:off x="1553895" y="4994117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3" name="TextBox 36">
            <a:extLst>
              <a:ext uri="{FF2B5EF4-FFF2-40B4-BE49-F238E27FC236}">
                <a16:creationId xmlns:a16="http://schemas.microsoft.com/office/drawing/2014/main" id="{31714B03-1873-48FA-90A4-3B1CEC5D28A0}"/>
              </a:ext>
            </a:extLst>
          </p:cNvPr>
          <p:cNvSpPr txBox="1"/>
          <p:nvPr/>
        </p:nvSpPr>
        <p:spPr>
          <a:xfrm>
            <a:off x="1225509" y="485204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BA50256C-1C2F-43EF-8832-8AB11942A052}"/>
              </a:ext>
            </a:extLst>
          </p:cNvPr>
          <p:cNvCxnSpPr>
            <a:cxnSpLocks/>
          </p:cNvCxnSpPr>
          <p:nvPr/>
        </p:nvCxnSpPr>
        <p:spPr>
          <a:xfrm>
            <a:off x="1553895" y="5263805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5" name="TextBox 38">
            <a:extLst>
              <a:ext uri="{FF2B5EF4-FFF2-40B4-BE49-F238E27FC236}">
                <a16:creationId xmlns:a16="http://schemas.microsoft.com/office/drawing/2014/main" id="{AC1236D9-5776-495E-A704-5A94241F610C}"/>
              </a:ext>
            </a:extLst>
          </p:cNvPr>
          <p:cNvSpPr txBox="1"/>
          <p:nvPr/>
        </p:nvSpPr>
        <p:spPr>
          <a:xfrm>
            <a:off x="1225509" y="512173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2134B421-2F9D-4E03-AAD0-D321C9BFDBEF}"/>
              </a:ext>
            </a:extLst>
          </p:cNvPr>
          <p:cNvCxnSpPr>
            <a:cxnSpLocks/>
          </p:cNvCxnSpPr>
          <p:nvPr/>
        </p:nvCxnSpPr>
        <p:spPr>
          <a:xfrm>
            <a:off x="1560031" y="4636193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7" name="TextBox 40">
            <a:extLst>
              <a:ext uri="{FF2B5EF4-FFF2-40B4-BE49-F238E27FC236}">
                <a16:creationId xmlns:a16="http://schemas.microsoft.com/office/drawing/2014/main" id="{63CDA549-0CF3-43A2-9041-601712165CF0}"/>
              </a:ext>
            </a:extLst>
          </p:cNvPr>
          <p:cNvSpPr txBox="1"/>
          <p:nvPr/>
        </p:nvSpPr>
        <p:spPr>
          <a:xfrm>
            <a:off x="1231645" y="449412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8" name="Straight Connector 57">
            <a:extLst>
              <a:ext uri="{FF2B5EF4-FFF2-40B4-BE49-F238E27FC236}">
                <a16:creationId xmlns:a16="http://schemas.microsoft.com/office/drawing/2014/main" id="{CC6C1EA1-0DE9-4D95-B410-B52A61F263F8}"/>
              </a:ext>
            </a:extLst>
          </p:cNvPr>
          <p:cNvCxnSpPr>
            <a:cxnSpLocks/>
          </p:cNvCxnSpPr>
          <p:nvPr/>
        </p:nvCxnSpPr>
        <p:spPr>
          <a:xfrm>
            <a:off x="1553895" y="4431392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9" name="TextBox 42">
            <a:extLst>
              <a:ext uri="{FF2B5EF4-FFF2-40B4-BE49-F238E27FC236}">
                <a16:creationId xmlns:a16="http://schemas.microsoft.com/office/drawing/2014/main" id="{E72F7532-1FAD-44E1-9F69-7CFF23CF6597}"/>
              </a:ext>
            </a:extLst>
          </p:cNvPr>
          <p:cNvSpPr txBox="1"/>
          <p:nvPr/>
        </p:nvSpPr>
        <p:spPr>
          <a:xfrm>
            <a:off x="1225509" y="428254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0" name="Straight Connector 59">
            <a:extLst>
              <a:ext uri="{FF2B5EF4-FFF2-40B4-BE49-F238E27FC236}">
                <a16:creationId xmlns:a16="http://schemas.microsoft.com/office/drawing/2014/main" id="{7E957595-D17A-4B1C-A021-4F937F9004F8}"/>
              </a:ext>
            </a:extLst>
          </p:cNvPr>
          <p:cNvCxnSpPr>
            <a:cxnSpLocks/>
          </p:cNvCxnSpPr>
          <p:nvPr/>
        </p:nvCxnSpPr>
        <p:spPr>
          <a:xfrm>
            <a:off x="1553895" y="4298492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1" name="TextBox 42">
            <a:extLst>
              <a:ext uri="{FF2B5EF4-FFF2-40B4-BE49-F238E27FC236}">
                <a16:creationId xmlns:a16="http://schemas.microsoft.com/office/drawing/2014/main" id="{68B698B9-E869-4EAB-86C1-FE94827427B8}"/>
              </a:ext>
            </a:extLst>
          </p:cNvPr>
          <p:cNvSpPr txBox="1"/>
          <p:nvPr/>
        </p:nvSpPr>
        <p:spPr>
          <a:xfrm>
            <a:off x="1140549" y="4149649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335946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4</Words>
  <Application>Microsoft Office PowerPoint</Application>
  <PresentationFormat>Widescreen</PresentationFormat>
  <Paragraphs>3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asmin Carvalho Schäfer</dc:creator>
  <cp:lastModifiedBy>mnagata</cp:lastModifiedBy>
  <cp:revision>5</cp:revision>
  <dcterms:created xsi:type="dcterms:W3CDTF">2024-08-13T14:15:55Z</dcterms:created>
  <dcterms:modified xsi:type="dcterms:W3CDTF">2024-08-14T22:00:51Z</dcterms:modified>
</cp:coreProperties>
</file>